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5100"/>
  </p:normalViewPr>
  <p:slideViewPr>
    <p:cSldViewPr snapToGrid="0" snapToObjects="1">
      <p:cViewPr varScale="1">
        <p:scale>
          <a:sx n="88" d="100"/>
          <a:sy n="88" d="100"/>
        </p:scale>
        <p:origin x="94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4A1611-B377-BE45-B2AF-DA6AFC934A1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7ABA9E9-F13E-214B-B473-0950AB83FB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781523-1F7A-5E45-8B64-9CA4AD4926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51E80-AD5B-0843-A18C-2E3523422499}" type="datetimeFigureOut">
              <a:rPr lang="en-US" smtClean="0"/>
              <a:t>1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427AFE-BA37-FF41-B2C3-1BB3B82B4A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06CCA5-300E-7E47-83A7-994E4FFB54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D02A70-1285-7248-A983-EA4B2A3E04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11035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CE7BE3-9888-F541-9179-D06C703AE1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9431344-7B2E-784A-887C-4D8EABE0E6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532AD0-9DCB-3144-AC89-944FADCDED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51E80-AD5B-0843-A18C-2E3523422499}" type="datetimeFigureOut">
              <a:rPr lang="en-US" smtClean="0"/>
              <a:t>1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795C06-8F44-4E4B-A4DE-F59471B6DD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D780F3-6414-4343-8094-DAAE23D95D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D02A70-1285-7248-A983-EA4B2A3E04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4068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6C32710-63BE-DD4D-AFC1-80FFFF796BC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DFB1607-C9A2-4446-8B9C-473C5F4FCA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979F9F-2E66-CB4F-B9FE-ECD66B6ED7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51E80-AD5B-0843-A18C-2E3523422499}" type="datetimeFigureOut">
              <a:rPr lang="en-US" smtClean="0"/>
              <a:t>1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5FA847-9FD3-BD49-8718-DCF8E292AA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80F93A-254C-704D-88AD-F4C5D7C8C0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D02A70-1285-7248-A983-EA4B2A3E04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2306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96B65F-E5D6-B140-8B56-BD48D3C562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990DBE-E3EA-2143-8BB8-98328C09ED9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A3F3A5-A0EF-3944-801A-79E670657D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51E80-AD5B-0843-A18C-2E3523422499}" type="datetimeFigureOut">
              <a:rPr lang="en-US" smtClean="0"/>
              <a:t>1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85A962-75C5-7A45-BF94-69D8390638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DAA56B-B860-6D4D-A2BE-CB59646A6B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D02A70-1285-7248-A983-EA4B2A3E04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3716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1FA4C6-D12E-DD40-87E4-7375E086A5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BCA287-F759-0C41-995A-306F86DEC5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D8F4C5-3DB6-7043-BCF0-7B405749BA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51E80-AD5B-0843-A18C-2E3523422499}" type="datetimeFigureOut">
              <a:rPr lang="en-US" smtClean="0"/>
              <a:t>1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39EAE7-583E-E74E-AB55-437651A06B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FAE9FD-78FB-5A40-B930-A982A0483C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D02A70-1285-7248-A983-EA4B2A3E04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1700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2022F1-2219-364B-A9B7-7E345B2AAB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722DC1-6AF3-6349-AEEC-77678A76F1C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90CEDA1-CEF9-A245-B3A1-6A6D5161B6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B1FC68E-D2E4-D84B-9615-299185C3DA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51E80-AD5B-0843-A18C-2E3523422499}" type="datetimeFigureOut">
              <a:rPr lang="en-US" smtClean="0"/>
              <a:t>12/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FABC49-8130-4548-AA11-B57020CBD4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A7A388A-2F66-EC49-9B86-89A1CEB4EA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D02A70-1285-7248-A983-EA4B2A3E04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09299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9450A5-2483-8B47-B178-186A3951D7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6D674B-C689-D942-817A-71A45C9825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47B1126-9685-4648-B137-E1E5ADBDBA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9E45063-6E70-6040-B9BE-1EC7C0BB8ED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CB203DE-A001-2F4E-9DAC-BD22050CBEC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A3E694D-2C85-C649-ACFC-D74663F126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51E80-AD5B-0843-A18C-2E3523422499}" type="datetimeFigureOut">
              <a:rPr lang="en-US" smtClean="0"/>
              <a:t>12/5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061C9EB-7E9C-0F45-88AF-1480AD96D8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24EB1C1-79A0-FF4A-84F5-780041527E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D02A70-1285-7248-A983-EA4B2A3E04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0049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3CD561-CF67-714B-8427-27A40EC7C2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261DBB9-3C7D-AD4D-8AF7-CF34BA40ED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51E80-AD5B-0843-A18C-2E3523422499}" type="datetimeFigureOut">
              <a:rPr lang="en-US" smtClean="0"/>
              <a:t>12/5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9510F09-BD75-B443-B9A6-7AC44BDC5A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F175CE2-FB10-3D4A-9256-92E58C0C49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D02A70-1285-7248-A983-EA4B2A3E04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73819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FABCE76-8BF5-6840-8109-14EDC083FE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51E80-AD5B-0843-A18C-2E3523422499}" type="datetimeFigureOut">
              <a:rPr lang="en-US" smtClean="0"/>
              <a:t>12/5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63DE3C1-3F0A-934D-BED0-E84813EAB5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89418EE-9110-864B-BD01-3426ABFB0E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D02A70-1285-7248-A983-EA4B2A3E04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39112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218CFC-51FE-C642-A85D-6863BE42FC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080417-540E-E742-A1C4-342C43797D5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46BAF8F-F633-C547-8D46-AB02577EF2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80723C-56DC-9940-9BDA-77A4E37C77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51E80-AD5B-0843-A18C-2E3523422499}" type="datetimeFigureOut">
              <a:rPr lang="en-US" smtClean="0"/>
              <a:t>12/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A39F68-F0BB-F045-8AC3-D98A465615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FFBE07B-3BDD-A14B-8F1C-EF345643DA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D02A70-1285-7248-A983-EA4B2A3E04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49777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8BD5CC-7C42-524B-948D-E212798481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BF714DF-EBB8-B844-9DA4-5CB6417674D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F92AB5A-845C-9C40-8FAF-912039B2DD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4A2FEB-6D59-3A40-83C7-04FD283E2B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51E80-AD5B-0843-A18C-2E3523422499}" type="datetimeFigureOut">
              <a:rPr lang="en-US" smtClean="0"/>
              <a:t>12/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322427A-4B68-BC4B-A660-0F55DFBDE7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8DF3C1-730D-E841-BA61-D026342A28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D02A70-1285-7248-A983-EA4B2A3E04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8229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9323200-1646-BD43-BE44-BE5EB8BD7E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5E3DEC-86BC-6A45-B3C4-C526BDA66F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71C7A1-C4BA-2F4E-A072-319BD8CA326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A51E80-AD5B-0843-A18C-2E3523422499}" type="datetimeFigureOut">
              <a:rPr lang="en-US" smtClean="0"/>
              <a:t>1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378C0D-7D5A-7D46-9AFB-C6095B5812D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38992A-B69D-4D43-AFDE-E97540539B4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D02A70-1285-7248-A983-EA4B2A3E04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00327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3" Type="http://schemas.openxmlformats.org/officeDocument/2006/relationships/image" Target="../media/image2.tif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30DE4DD-257E-DB4F-832F-05671D69E50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15280" t="-10036" r="-18898" b="-17375"/>
          <a:stretch/>
        </p:blipFill>
        <p:spPr>
          <a:xfrm>
            <a:off x="4022370" y="1170223"/>
            <a:ext cx="2453832" cy="1585732"/>
          </a:xfrm>
          <a:prstGeom prst="rect">
            <a:avLst/>
          </a:prstGeom>
          <a:ln>
            <a:noFill/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79CD08E-2AD1-6C44-A9A5-BC826AC79A3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12038" t="-6716" r="-10415" b="-8786"/>
          <a:stretch/>
        </p:blipFill>
        <p:spPr>
          <a:xfrm>
            <a:off x="256582" y="513458"/>
            <a:ext cx="3032567" cy="1481559"/>
          </a:xfrm>
          <a:prstGeom prst="rect">
            <a:avLst/>
          </a:prstGeom>
          <a:ln>
            <a:noFill/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ACF8FF1-2BD0-0B42-B8E9-7AE36B7AE8D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-6165" t="-6628" r="-9694" b="-10245"/>
          <a:stretch/>
        </p:blipFill>
        <p:spPr>
          <a:xfrm>
            <a:off x="881186" y="2028263"/>
            <a:ext cx="2766350" cy="1261638"/>
          </a:xfrm>
          <a:prstGeom prst="rect">
            <a:avLst/>
          </a:prstGeom>
          <a:ln>
            <a:noFill/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C260B11-EAA4-AD47-8A1F-1FA38FC7582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-16968" t="-10242" r="-16463" b="-5372"/>
          <a:stretch/>
        </p:blipFill>
        <p:spPr>
          <a:xfrm>
            <a:off x="3805041" y="2690828"/>
            <a:ext cx="2592729" cy="925972"/>
          </a:xfrm>
          <a:prstGeom prst="rect">
            <a:avLst/>
          </a:prstGeom>
          <a:ln>
            <a:noFill/>
          </a:ln>
        </p:spPr>
      </p:pic>
      <p:sp>
        <p:nvSpPr>
          <p:cNvPr id="8" name="ZoneTexte 5">
            <a:extLst>
              <a:ext uri="{FF2B5EF4-FFF2-40B4-BE49-F238E27FC236}">
                <a16:creationId xmlns:a16="http://schemas.microsoft.com/office/drawing/2014/main" id="{B0E44D7A-2D6B-8D43-B165-61A588FC95D0}"/>
              </a:ext>
            </a:extLst>
          </p:cNvPr>
          <p:cNvSpPr txBox="1"/>
          <p:nvPr/>
        </p:nvSpPr>
        <p:spPr>
          <a:xfrm>
            <a:off x="1313486" y="217016"/>
            <a:ext cx="11743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3C</a:t>
            </a:r>
            <a:endParaRPr lang="fr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80C0D9E4-CDA0-734C-BD2B-92838151D3A3}"/>
              </a:ext>
            </a:extLst>
          </p:cNvPr>
          <p:cNvSpPr/>
          <p:nvPr/>
        </p:nvSpPr>
        <p:spPr>
          <a:xfrm>
            <a:off x="1037446" y="873298"/>
            <a:ext cx="1322599" cy="51115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18A30EB4-CF9A-414E-A87F-C5CE697CF49D}"/>
              </a:ext>
            </a:extLst>
          </p:cNvPr>
          <p:cNvSpPr/>
          <p:nvPr/>
        </p:nvSpPr>
        <p:spPr>
          <a:xfrm>
            <a:off x="1446802" y="2448448"/>
            <a:ext cx="1322599" cy="51115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7018FA43-F82A-AB4A-9F63-75F3D7777E33}"/>
              </a:ext>
            </a:extLst>
          </p:cNvPr>
          <p:cNvSpPr/>
          <p:nvPr/>
        </p:nvSpPr>
        <p:spPr>
          <a:xfrm>
            <a:off x="4517873" y="1778226"/>
            <a:ext cx="1322599" cy="271577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12" name="ZoneTexte 9">
            <a:extLst>
              <a:ext uri="{FF2B5EF4-FFF2-40B4-BE49-F238E27FC236}">
                <a16:creationId xmlns:a16="http://schemas.microsoft.com/office/drawing/2014/main" id="{BDA4E6E3-E9E7-F742-865A-4D5304EBFD5B}"/>
              </a:ext>
            </a:extLst>
          </p:cNvPr>
          <p:cNvSpPr txBox="1"/>
          <p:nvPr/>
        </p:nvSpPr>
        <p:spPr>
          <a:xfrm>
            <a:off x="6160865" y="3015314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p90</a:t>
            </a:r>
          </a:p>
        </p:txBody>
      </p:sp>
      <p:sp>
        <p:nvSpPr>
          <p:cNvPr id="13" name="ZoneTexte 9">
            <a:extLst>
              <a:ext uri="{FF2B5EF4-FFF2-40B4-BE49-F238E27FC236}">
                <a16:creationId xmlns:a16="http://schemas.microsoft.com/office/drawing/2014/main" id="{E7635CF5-EA9D-9847-A084-BEF861A7DEEE}"/>
              </a:ext>
            </a:extLst>
          </p:cNvPr>
          <p:cNvSpPr txBox="1"/>
          <p:nvPr/>
        </p:nvSpPr>
        <p:spPr>
          <a:xfrm>
            <a:off x="6160865" y="1730863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rd7</a:t>
            </a:r>
          </a:p>
        </p:txBody>
      </p:sp>
      <p:sp>
        <p:nvSpPr>
          <p:cNvPr id="14" name="ZoneTexte 9">
            <a:extLst>
              <a:ext uri="{FF2B5EF4-FFF2-40B4-BE49-F238E27FC236}">
                <a16:creationId xmlns:a16="http://schemas.microsoft.com/office/drawing/2014/main" id="{E7E543CC-B3FF-2A4F-88FE-4DE6C4846761}"/>
              </a:ext>
            </a:extLst>
          </p:cNvPr>
          <p:cNvSpPr txBox="1"/>
          <p:nvPr/>
        </p:nvSpPr>
        <p:spPr>
          <a:xfrm>
            <a:off x="3368493" y="2561979"/>
            <a:ext cx="6832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Ebp1</a:t>
            </a:r>
          </a:p>
        </p:txBody>
      </p:sp>
      <p:sp>
        <p:nvSpPr>
          <p:cNvPr id="15" name="ZoneTexte 9">
            <a:extLst>
              <a:ext uri="{FF2B5EF4-FFF2-40B4-BE49-F238E27FC236}">
                <a16:creationId xmlns:a16="http://schemas.microsoft.com/office/drawing/2014/main" id="{FE6C615A-6700-CF40-80B7-60657DF3ED03}"/>
              </a:ext>
            </a:extLst>
          </p:cNvPr>
          <p:cNvSpPr txBox="1"/>
          <p:nvPr/>
        </p:nvSpPr>
        <p:spPr>
          <a:xfrm>
            <a:off x="3008919" y="960814"/>
            <a:ext cx="7825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4Ebp1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B1F59EA6-3612-6E4D-A4F7-156E199D5FCF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-49347" t="-4130" r="-17217" b="-7853"/>
          <a:stretch/>
        </p:blipFill>
        <p:spPr>
          <a:xfrm rot="5400000">
            <a:off x="1294022" y="2800211"/>
            <a:ext cx="1523067" cy="2033728"/>
          </a:xfrm>
          <a:prstGeom prst="rect">
            <a:avLst/>
          </a:prstGeom>
          <a:ln>
            <a:noFill/>
          </a:ln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189B023A-3E22-EA4C-A89C-8C0C140EBECF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-3707" t="-6158" r="-12665" b="-10985"/>
          <a:stretch/>
        </p:blipFill>
        <p:spPr>
          <a:xfrm>
            <a:off x="1260338" y="4610086"/>
            <a:ext cx="1950842" cy="1071105"/>
          </a:xfrm>
          <a:prstGeom prst="rect">
            <a:avLst/>
          </a:prstGeom>
          <a:ln>
            <a:noFill/>
          </a:ln>
        </p:spPr>
      </p:pic>
      <p:sp>
        <p:nvSpPr>
          <p:cNvPr id="18" name="ZoneTexte 18">
            <a:extLst>
              <a:ext uri="{FF2B5EF4-FFF2-40B4-BE49-F238E27FC236}">
                <a16:creationId xmlns:a16="http://schemas.microsoft.com/office/drawing/2014/main" id="{7C902246-E44F-2B42-BE0B-8682C9E73B71}"/>
              </a:ext>
            </a:extLst>
          </p:cNvPr>
          <p:cNvSpPr txBox="1"/>
          <p:nvPr/>
        </p:nvSpPr>
        <p:spPr>
          <a:xfrm>
            <a:off x="3018674" y="4847979"/>
            <a:ext cx="7729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Times New Roman"/>
                <a:cs typeface="Times New Roman"/>
              </a:rPr>
              <a:t>pH2AX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481EECC0-7675-2742-9D7E-ED8A0891BF77}"/>
              </a:ext>
            </a:extLst>
          </p:cNvPr>
          <p:cNvSpPr txBox="1"/>
          <p:nvPr/>
        </p:nvSpPr>
        <p:spPr>
          <a:xfrm>
            <a:off x="3072420" y="3798609"/>
            <a:ext cx="6110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err="1">
                <a:latin typeface="Times New Roman"/>
                <a:cs typeface="Times New Roman"/>
              </a:rPr>
              <a:t>Tigar</a:t>
            </a:r>
            <a:endParaRPr lang="fr-FR" sz="1400" b="1" dirty="0">
              <a:latin typeface="Times New Roman"/>
              <a:cs typeface="Times New Roman"/>
            </a:endParaRP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72A1951F-FFE6-B242-9C5C-8324F4805915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-5716" t="-14034" r="-1159" b="-16615"/>
          <a:stretch/>
        </p:blipFill>
        <p:spPr>
          <a:xfrm>
            <a:off x="1037446" y="5547192"/>
            <a:ext cx="2022365" cy="1310808"/>
          </a:xfrm>
          <a:prstGeom prst="rect">
            <a:avLst/>
          </a:prstGeom>
          <a:ln>
            <a:noFill/>
          </a:ln>
        </p:spPr>
      </p:pic>
      <p:sp>
        <p:nvSpPr>
          <p:cNvPr id="21" name="Rectangle 20">
            <a:extLst>
              <a:ext uri="{FF2B5EF4-FFF2-40B4-BE49-F238E27FC236}">
                <a16:creationId xmlns:a16="http://schemas.microsoft.com/office/drawing/2014/main" id="{EA476021-8B4A-5347-B25A-5A5386E259EC}"/>
              </a:ext>
            </a:extLst>
          </p:cNvPr>
          <p:cNvSpPr/>
          <p:nvPr/>
        </p:nvSpPr>
        <p:spPr>
          <a:xfrm>
            <a:off x="1456778" y="4770055"/>
            <a:ext cx="1322599" cy="51115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sp>
        <p:nvSpPr>
          <p:cNvPr id="22" name="ZoneTexte 18">
            <a:extLst>
              <a:ext uri="{FF2B5EF4-FFF2-40B4-BE49-F238E27FC236}">
                <a16:creationId xmlns:a16="http://schemas.microsoft.com/office/drawing/2014/main" id="{8CF39AD8-63A2-C24A-B0C6-9042E3CC9493}"/>
              </a:ext>
            </a:extLst>
          </p:cNvPr>
          <p:cNvSpPr txBox="1"/>
          <p:nvPr/>
        </p:nvSpPr>
        <p:spPr>
          <a:xfrm>
            <a:off x="3059811" y="5879845"/>
            <a:ext cx="92204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>
                <a:latin typeface="Times New Roman"/>
                <a:cs typeface="Times New Roman"/>
              </a:rPr>
              <a:t>Cleaved</a:t>
            </a:r>
            <a:endParaRPr lang="fr-FR" sz="1400" b="1" dirty="0">
              <a:latin typeface="Times New Roman"/>
              <a:cs typeface="Times New Roman"/>
            </a:endParaRPr>
          </a:p>
          <a:p>
            <a:r>
              <a:rPr lang="fr-FR" sz="1400" b="1" dirty="0">
                <a:latin typeface="Times New Roman"/>
                <a:cs typeface="Times New Roman"/>
              </a:rPr>
              <a:t>caspase 3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E75381E0-D8AA-E544-A239-144CD11C9312}"/>
              </a:ext>
            </a:extLst>
          </p:cNvPr>
          <p:cNvSpPr/>
          <p:nvPr/>
        </p:nvSpPr>
        <p:spPr>
          <a:xfrm>
            <a:off x="1511182" y="5830358"/>
            <a:ext cx="1322599" cy="51115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BE"/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FC8DDEDB-12A9-A040-9942-202A5A2BE721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 flipV="1">
            <a:off x="4818243" y="3585200"/>
            <a:ext cx="647700" cy="1905000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405766B3-B56A-B840-9A7F-D9D997D0223C}"/>
              </a:ext>
            </a:extLst>
          </p:cNvPr>
          <p:cNvSpPr txBox="1"/>
          <p:nvPr/>
        </p:nvSpPr>
        <p:spPr>
          <a:xfrm>
            <a:off x="4189593" y="4899865"/>
            <a:ext cx="230595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p90 (second membrane, not shown in Figure 3C)</a:t>
            </a:r>
          </a:p>
        </p:txBody>
      </p:sp>
    </p:spTree>
    <p:extLst>
      <p:ext uri="{BB962C8B-B14F-4D97-AF65-F5344CB8AC3E}">
        <p14:creationId xmlns:p14="http://schemas.microsoft.com/office/powerpoint/2010/main" val="42065402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</Words>
  <Application>Microsoft Macintosh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Microsoft Office User</dc:creator>
  <cp:keywords/>
  <dc:description/>
  <cp:lastModifiedBy>Microsoft Office User</cp:lastModifiedBy>
  <cp:revision>1</cp:revision>
  <dcterms:created xsi:type="dcterms:W3CDTF">2025-12-05T16:50:08Z</dcterms:created>
  <dcterms:modified xsi:type="dcterms:W3CDTF">2025-12-05T16:50:29Z</dcterms:modified>
  <cp:category/>
</cp:coreProperties>
</file>